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7" r:id="rId3"/>
    <p:sldId id="278" r:id="rId4"/>
    <p:sldId id="276" r:id="rId5"/>
    <p:sldId id="279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77" autoAdjust="0"/>
    <p:restoredTop sz="92326" autoAdjust="0"/>
  </p:normalViewPr>
  <p:slideViewPr>
    <p:cSldViewPr snapToGrid="0">
      <p:cViewPr varScale="1">
        <p:scale>
          <a:sx n="107" d="100"/>
          <a:sy n="107" d="100"/>
        </p:scale>
        <p:origin x="7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4424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6106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054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2377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4976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8529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1887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5696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2786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7836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ko-KR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B3CDC9-FB6B-437E-A9F9-FF95277E6856}" type="datetimeFigureOut">
              <a:rPr lang="ko-KR" altLang="en-US" smtClean="0"/>
              <a:t>2024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BFB81-3E61-4128-9525-5E15F6E5E3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9678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8.jpeg"/><Relationship Id="rId5" Type="http://schemas.openxmlformats.org/officeDocument/2006/relationships/image" Target="../media/image4.jpeg"/><Relationship Id="rId10" Type="http://schemas.microsoft.com/office/2007/relationships/hdphoto" Target="../media/hdphoto2.wdp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image" Target="../media/image14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jpeg"/><Relationship Id="rId9" Type="http://schemas.openxmlformats.org/officeDocument/2006/relationships/image" Target="../media/image2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7" Type="http://schemas.openxmlformats.org/officeDocument/2006/relationships/image" Target="../media/image28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tif"/><Relationship Id="rId5" Type="http://schemas.openxmlformats.org/officeDocument/2006/relationships/image" Target="../media/image26.jpeg"/><Relationship Id="rId4" Type="http://schemas.openxmlformats.org/officeDocument/2006/relationships/image" Target="../media/image25.jpe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microsoft.com/office/2007/relationships/hdphoto" Target="../media/hdphoto3.wdp"/><Relationship Id="rId7" Type="http://schemas.openxmlformats.org/officeDocument/2006/relationships/image" Target="../media/image32.png"/><Relationship Id="rId12" Type="http://schemas.openxmlformats.org/officeDocument/2006/relationships/image" Target="../media/image36.jpe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jpeg"/><Relationship Id="rId11" Type="http://schemas.openxmlformats.org/officeDocument/2006/relationships/image" Target="../media/image35.jpeg"/><Relationship Id="rId5" Type="http://schemas.microsoft.com/office/2007/relationships/hdphoto" Target="../media/hdphoto4.wdp"/><Relationship Id="rId10" Type="http://schemas.openxmlformats.org/officeDocument/2006/relationships/image" Target="../media/image34.jpeg"/><Relationship Id="rId4" Type="http://schemas.openxmlformats.org/officeDocument/2006/relationships/image" Target="../media/image30.png"/><Relationship Id="rId9" Type="http://schemas.openxmlformats.org/officeDocument/2006/relationships/image" Target="../media/image3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122693" y="706936"/>
            <a:ext cx="172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534613" y="725226"/>
            <a:ext cx="118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 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58101" y="1411884"/>
            <a:ext cx="9650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yloid Beta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857881" y="3887938"/>
            <a:ext cx="6903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E-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840425" y="5533850"/>
            <a:ext cx="66292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689"/>
          <a:stretch/>
        </p:blipFill>
        <p:spPr>
          <a:xfrm flipH="1">
            <a:off x="4563079" y="5125144"/>
            <a:ext cx="1280160" cy="1188720"/>
          </a:xfrm>
          <a:prstGeom prst="rect">
            <a:avLst/>
          </a:prstGeom>
        </p:spPr>
      </p:pic>
      <p:pic>
        <p:nvPicPr>
          <p:cNvPr id="29" name="Picture 28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689"/>
          <a:stretch/>
        </p:blipFill>
        <p:spPr>
          <a:xfrm>
            <a:off x="6283469" y="5125144"/>
            <a:ext cx="1280160" cy="1188720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>
            <a:off x="3836589" y="1665800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848844" y="4117640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822873" y="5811084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7511543" y="398880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578743" y="1477985"/>
            <a:ext cx="42511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05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  <a:endParaRPr lang="ko-KR" altLang="en-US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511543" y="5660808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3461018" y="457545"/>
            <a:ext cx="8690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01"/>
          <a:stretch/>
        </p:blipFill>
        <p:spPr>
          <a:xfrm>
            <a:off x="6283469" y="3777374"/>
            <a:ext cx="1280160" cy="1188720"/>
          </a:xfrm>
          <a:prstGeom prst="rect">
            <a:avLst/>
          </a:prstGeom>
        </p:spPr>
      </p:pic>
      <p:pic>
        <p:nvPicPr>
          <p:cNvPr id="8" name="Picture 7"/>
          <p:cNvPicPr preferRelativeResize="0"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17"/>
          <a:stretch/>
        </p:blipFill>
        <p:spPr>
          <a:xfrm>
            <a:off x="4563079" y="2416662"/>
            <a:ext cx="1280160" cy="1227543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3795441" y="2457198"/>
            <a:ext cx="6903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Tau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3823609" y="2723854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/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3469" y="2429603"/>
            <a:ext cx="1280160" cy="118872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7511543" y="2633832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 preferRelativeResize="0"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079" y="3790315"/>
            <a:ext cx="1280160" cy="1188720"/>
          </a:xfrm>
          <a:prstGeom prst="rect">
            <a:avLst/>
          </a:prstGeom>
        </p:spPr>
      </p:pic>
      <p:pic>
        <p:nvPicPr>
          <p:cNvPr id="14" name="Picture 13"/>
          <p:cNvPicPr preferRelativeResize="0"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3079" y="1188818"/>
            <a:ext cx="1280160" cy="1081734"/>
          </a:xfrm>
          <a:prstGeom prst="rect">
            <a:avLst/>
          </a:prstGeom>
        </p:spPr>
      </p:pic>
      <p:pic>
        <p:nvPicPr>
          <p:cNvPr id="15" name="Picture 14"/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3469" y="1188818"/>
            <a:ext cx="1280160" cy="1081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7187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5990238" y="1348421"/>
            <a:ext cx="172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421041" y="1370212"/>
            <a:ext cx="118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 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779218" y="3197011"/>
            <a:ext cx="56938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AP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0" t="-1" r="47732" b="34676"/>
          <a:stretch/>
        </p:blipFill>
        <p:spPr>
          <a:xfrm>
            <a:off x="4470253" y="1693928"/>
            <a:ext cx="1155913" cy="1031343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3813879" y="2263022"/>
            <a:ext cx="49244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ba-1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764143" y="4850875"/>
            <a:ext cx="65753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493"/>
          <a:stretch/>
        </p:blipFill>
        <p:spPr>
          <a:xfrm>
            <a:off x="6245938" y="4281228"/>
            <a:ext cx="1179111" cy="1229592"/>
          </a:xfrm>
          <a:prstGeom prst="rect">
            <a:avLst/>
          </a:prstGeom>
        </p:spPr>
      </p:pic>
      <p:cxnSp>
        <p:nvCxnSpPr>
          <p:cNvPr id="15" name="Straight Arrow Connector 14"/>
          <p:cNvCxnSpPr/>
          <p:nvPr/>
        </p:nvCxnSpPr>
        <p:spPr>
          <a:xfrm>
            <a:off x="3714899" y="3458805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711088" y="2500095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3743897" y="5104975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38" b="25397"/>
          <a:stretch/>
        </p:blipFill>
        <p:spPr>
          <a:xfrm>
            <a:off x="4482847" y="2909213"/>
            <a:ext cx="1130725" cy="1169209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7410323" y="3365364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406513" y="230702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3849" y="4262364"/>
            <a:ext cx="1188721" cy="1248455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7439321" y="4884942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711088" y="845237"/>
            <a:ext cx="8690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335"/>
          <a:stretch/>
        </p:blipFill>
        <p:spPr>
          <a:xfrm>
            <a:off x="6259421" y="1720303"/>
            <a:ext cx="1152144" cy="98703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9123" y="2922686"/>
            <a:ext cx="1132740" cy="11431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2980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189363" y="1112522"/>
            <a:ext cx="172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590455" y="1112522"/>
            <a:ext cx="118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 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901568" y="2976661"/>
            <a:ext cx="71686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ko-KR" sz="105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fKpB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3947837" y="4590849"/>
            <a:ext cx="510076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</a:t>
            </a:r>
            <a:r>
              <a:rPr lang="el-GR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873630" y="5784260"/>
            <a:ext cx="6435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246"/>
          <a:stretch/>
        </p:blipFill>
        <p:spPr>
          <a:xfrm>
            <a:off x="4591846" y="5444666"/>
            <a:ext cx="1209881" cy="1037616"/>
          </a:xfrm>
          <a:prstGeom prst="rect">
            <a:avLst/>
          </a:prstGeom>
        </p:spPr>
      </p:pic>
      <p:pic>
        <p:nvPicPr>
          <p:cNvPr id="2" name="Picture 1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0821"/>
          <a:stretch/>
        </p:blipFill>
        <p:spPr>
          <a:xfrm>
            <a:off x="4593509" y="4044491"/>
            <a:ext cx="1206554" cy="1225648"/>
          </a:xfrm>
          <a:prstGeom prst="rect">
            <a:avLst/>
          </a:prstGeom>
        </p:spPr>
      </p:pic>
      <p:cxnSp>
        <p:nvCxnSpPr>
          <p:cNvPr id="16" name="Straight Arrow Connector 15"/>
          <p:cNvCxnSpPr/>
          <p:nvPr/>
        </p:nvCxnSpPr>
        <p:spPr>
          <a:xfrm>
            <a:off x="3910987" y="3222307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877323" y="4844765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3869857" y="6038176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645565" y="303588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5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3" t="30290" r="45522" b="11252"/>
          <a:stretch/>
        </p:blipFill>
        <p:spPr>
          <a:xfrm>
            <a:off x="4618234" y="2789217"/>
            <a:ext cx="1157104" cy="1080746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68" t="25616" r="1033" b="6859"/>
          <a:stretch/>
        </p:blipFill>
        <p:spPr>
          <a:xfrm>
            <a:off x="6475131" y="2854441"/>
            <a:ext cx="1184890" cy="1081586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7645565" y="4691878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645565" y="5845761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424543" y="631266"/>
            <a:ext cx="8690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</a:t>
            </a:r>
          </a:p>
        </p:txBody>
      </p:sp>
      <p:pic>
        <p:nvPicPr>
          <p:cNvPr id="5" name="Picture 4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46" b="6692"/>
          <a:stretch/>
        </p:blipFill>
        <p:spPr>
          <a:xfrm>
            <a:off x="6475131" y="4074162"/>
            <a:ext cx="1184890" cy="1207008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11" b="5557"/>
          <a:stretch/>
        </p:blipFill>
        <p:spPr>
          <a:xfrm>
            <a:off x="6491297" y="1473163"/>
            <a:ext cx="1152559" cy="1243143"/>
          </a:xfrm>
          <a:prstGeom prst="rect">
            <a:avLst/>
          </a:prstGeom>
        </p:spPr>
      </p:pic>
      <p:sp>
        <p:nvSpPr>
          <p:cNvPr id="35" name="Rectangle 34"/>
          <p:cNvSpPr/>
          <p:nvPr/>
        </p:nvSpPr>
        <p:spPr>
          <a:xfrm>
            <a:off x="3920615" y="1453015"/>
            <a:ext cx="529311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LR4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3836258" y="1671264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7625033" y="1542097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0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5266" y="1453015"/>
            <a:ext cx="1163040" cy="1161674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988" b="19942"/>
          <a:stretch/>
        </p:blipFill>
        <p:spPr>
          <a:xfrm>
            <a:off x="6469837" y="5419304"/>
            <a:ext cx="1195479" cy="1037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9839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600790" y="1596825"/>
            <a:ext cx="172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00318" y="1596825"/>
            <a:ext cx="118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 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587844" y="3655431"/>
            <a:ext cx="6124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-1  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37317" y="1971207"/>
            <a:ext cx="7178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f-2 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13182" y="4698145"/>
            <a:ext cx="7444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4320"/>
          <a:stretch/>
        </p:blipFill>
        <p:spPr>
          <a:xfrm>
            <a:off x="5304471" y="4267780"/>
            <a:ext cx="1130799" cy="117023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08" r="6876"/>
          <a:stretch/>
        </p:blipFill>
        <p:spPr>
          <a:xfrm>
            <a:off x="6897992" y="4267780"/>
            <a:ext cx="1162986" cy="1170234"/>
          </a:xfrm>
          <a:prstGeom prst="rect">
            <a:avLst/>
          </a:prstGeom>
        </p:spPr>
      </p:pic>
      <p:pic>
        <p:nvPicPr>
          <p:cNvPr id="2" name="Picture 1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2595" y="3095236"/>
            <a:ext cx="1114550" cy="1102705"/>
          </a:xfrm>
          <a:prstGeom prst="rect">
            <a:avLst/>
          </a:prstGeom>
        </p:spPr>
      </p:pic>
      <p:cxnSp>
        <p:nvCxnSpPr>
          <p:cNvPr id="17" name="Straight Arrow Connector 16"/>
          <p:cNvCxnSpPr/>
          <p:nvPr/>
        </p:nvCxnSpPr>
        <p:spPr>
          <a:xfrm>
            <a:off x="4545069" y="3928925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4547215" y="2220988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4536370" y="4979909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7992" y="3080142"/>
            <a:ext cx="1137046" cy="112269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8066134" y="367500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028994" y="2013771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8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8090686" y="482789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3810571" y="721065"/>
            <a:ext cx="8690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6</a:t>
            </a:r>
          </a:p>
        </p:txBody>
      </p:sp>
      <p:pic>
        <p:nvPicPr>
          <p:cNvPr id="4" name="Picture 3"/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193"/>
          <a:stretch/>
        </p:blipFill>
        <p:spPr>
          <a:xfrm>
            <a:off x="6884892" y="1972781"/>
            <a:ext cx="1133856" cy="1042416"/>
          </a:xfrm>
          <a:prstGeom prst="rect">
            <a:avLst/>
          </a:prstGeom>
        </p:spPr>
      </p:pic>
      <p:pic>
        <p:nvPicPr>
          <p:cNvPr id="5" name="Picture 4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676"/>
          <a:stretch/>
        </p:blipFill>
        <p:spPr>
          <a:xfrm>
            <a:off x="5302942" y="1982980"/>
            <a:ext cx="1133856" cy="1042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7516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338195" y="784181"/>
            <a:ext cx="17281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46306" y="766628"/>
            <a:ext cx="118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tex 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972862" y="4128518"/>
            <a:ext cx="4908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Picture 21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7421"/>
          <a:stretch/>
        </p:blipFill>
        <p:spPr>
          <a:xfrm>
            <a:off x="6548141" y="1091958"/>
            <a:ext cx="1188720" cy="1150973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5034"/>
          <a:stretch/>
        </p:blipFill>
        <p:spPr>
          <a:xfrm>
            <a:off x="4690621" y="2300620"/>
            <a:ext cx="1178497" cy="1228963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3936774" y="1008130"/>
            <a:ext cx="6799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D-95</a:t>
            </a:r>
          </a:p>
        </p:txBody>
      </p:sp>
      <p:sp>
        <p:nvSpPr>
          <p:cNvPr id="35" name="Rectangle 34"/>
          <p:cNvSpPr/>
          <p:nvPr/>
        </p:nvSpPr>
        <p:spPr>
          <a:xfrm>
            <a:off x="3886733" y="2891436"/>
            <a:ext cx="798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NAP-23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Picture 36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905"/>
          <a:stretch/>
        </p:blipFill>
        <p:spPr>
          <a:xfrm>
            <a:off x="4688817" y="4905232"/>
            <a:ext cx="1178497" cy="1097218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3972862" y="5311811"/>
            <a:ext cx="6734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tin </a:t>
            </a:r>
            <a:endParaRPr lang="en-US" altLang="ko-KR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 preferRelativeResize="0">
            <a:picLocks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7987" b="25246"/>
          <a:stretch/>
        </p:blipFill>
        <p:spPr>
          <a:xfrm>
            <a:off x="4685509" y="1099034"/>
            <a:ext cx="1181805" cy="1129375"/>
          </a:xfrm>
          <a:prstGeom prst="rect">
            <a:avLst/>
          </a:prstGeom>
        </p:spPr>
      </p:pic>
      <p:pic>
        <p:nvPicPr>
          <p:cNvPr id="4" name="Picture 3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400" b="10597"/>
          <a:stretch/>
        </p:blipFill>
        <p:spPr>
          <a:xfrm>
            <a:off x="6549945" y="4910963"/>
            <a:ext cx="1185113" cy="1091486"/>
          </a:xfrm>
          <a:prstGeom prst="rect">
            <a:avLst/>
          </a:prstGeom>
        </p:spPr>
      </p:pic>
      <p:pic>
        <p:nvPicPr>
          <p:cNvPr id="3" name="Picture 2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764"/>
          <a:stretch/>
        </p:blipFill>
        <p:spPr>
          <a:xfrm>
            <a:off x="6549945" y="2306350"/>
            <a:ext cx="1185113" cy="1237775"/>
          </a:xfrm>
          <a:prstGeom prst="rect">
            <a:avLst/>
          </a:prstGeom>
        </p:spPr>
      </p:pic>
      <p:pic>
        <p:nvPicPr>
          <p:cNvPr id="9" name="Picture 8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3549"/>
          <a:stretch/>
        </p:blipFill>
        <p:spPr>
          <a:xfrm>
            <a:off x="4685509" y="3585932"/>
            <a:ext cx="1188720" cy="1230267"/>
          </a:xfrm>
          <a:prstGeom prst="rect">
            <a:avLst/>
          </a:prstGeom>
        </p:spPr>
      </p:pic>
      <p:cxnSp>
        <p:nvCxnSpPr>
          <p:cNvPr id="16" name="Straight Arrow Connector 15"/>
          <p:cNvCxnSpPr/>
          <p:nvPr/>
        </p:nvCxnSpPr>
        <p:spPr>
          <a:xfrm>
            <a:off x="3869270" y="4405517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972862" y="1245068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3962376" y="3154179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3960572" y="5565727"/>
            <a:ext cx="69802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7766399" y="1115334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766399" y="2940212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735058" y="5453841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759894" y="4245067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5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8 </a:t>
            </a:r>
            <a:r>
              <a:rPr lang="en-US" altLang="ko-KR" sz="1050" b="1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altLang="ko-KR" sz="105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091488" y="401487"/>
            <a:ext cx="8690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Picture 26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94"/>
          <a:stretch/>
        </p:blipFill>
        <p:spPr>
          <a:xfrm>
            <a:off x="6546338" y="3584405"/>
            <a:ext cx="1188720" cy="1234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642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3</TotalTime>
  <Words>86</Words>
  <Application>Microsoft Office PowerPoint</Application>
  <PresentationFormat>Widescreen</PresentationFormat>
  <Paragraphs>5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322</cp:revision>
  <dcterms:created xsi:type="dcterms:W3CDTF">2023-03-09T09:09:55Z</dcterms:created>
  <dcterms:modified xsi:type="dcterms:W3CDTF">2024-06-28T01:31:03Z</dcterms:modified>
</cp:coreProperties>
</file>